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88" r:id="rId2"/>
  </p:sldIdLst>
  <p:sldSz cx="6858000" cy="9906000" type="A4"/>
  <p:notesSz cx="6669088" cy="97536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28" userDrawn="1">
          <p15:clr>
            <a:srgbClr val="A4A3A4"/>
          </p15:clr>
        </p15:guide>
        <p15:guide id="2" pos="2136" userDrawn="1">
          <p15:clr>
            <a:srgbClr val="A4A3A4"/>
          </p15:clr>
        </p15:guide>
        <p15:guide id="3" orient="horz" pos="1656" userDrawn="1">
          <p15:clr>
            <a:srgbClr val="A4A3A4"/>
          </p15:clr>
        </p15:guide>
        <p15:guide id="4" orient="horz" pos="336" userDrawn="1">
          <p15:clr>
            <a:srgbClr val="A4A3A4"/>
          </p15:clr>
        </p15:guide>
        <p15:guide id="6" orient="horz" pos="3336" userDrawn="1">
          <p15:clr>
            <a:srgbClr val="A4A3A4"/>
          </p15:clr>
        </p15:guide>
        <p15:guide id="7" pos="4104" userDrawn="1">
          <p15:clr>
            <a:srgbClr val="A4A3A4"/>
          </p15:clr>
        </p15:guide>
        <p15:guide id="8" pos="240" userDrawn="1">
          <p15:clr>
            <a:srgbClr val="A4A3A4"/>
          </p15:clr>
        </p15:guide>
        <p15:guide id="9" pos="1320" userDrawn="1">
          <p15:clr>
            <a:srgbClr val="A4A3A4"/>
          </p15:clr>
        </p15:guide>
        <p15:guide id="10" orient="horz" pos="507">
          <p15:clr>
            <a:srgbClr val="A4A3A4"/>
          </p15:clr>
        </p15:guide>
        <p15:guide id="11" orient="horz" pos="4632" userDrawn="1">
          <p15:clr>
            <a:srgbClr val="A4A3A4"/>
          </p15:clr>
        </p15:guide>
        <p15:guide id="12" pos="2616" userDrawn="1">
          <p15:clr>
            <a:srgbClr val="A4A3A4"/>
          </p15:clr>
        </p15:guide>
        <p15:guide id="13" pos="696" userDrawn="1">
          <p15:clr>
            <a:srgbClr val="A4A3A4"/>
          </p15:clr>
        </p15:guide>
        <p15:guide id="14" orient="horz" pos="4837">
          <p15:clr>
            <a:srgbClr val="A4A3A4"/>
          </p15:clr>
        </p15:guide>
        <p15:guide id="15" orient="horz" pos="1678">
          <p15:clr>
            <a:srgbClr val="A4A3A4"/>
          </p15:clr>
        </p15:guide>
        <p15:guide id="16" orient="horz" pos="410">
          <p15:clr>
            <a:srgbClr val="A4A3A4"/>
          </p15:clr>
        </p15:guide>
        <p15:guide id="17" orient="horz" pos="2976" userDrawn="1">
          <p15:clr>
            <a:srgbClr val="A4A3A4"/>
          </p15:clr>
        </p15:guide>
        <p15:guide id="18" orient="horz" pos="882">
          <p15:clr>
            <a:srgbClr val="A4A3A4"/>
          </p15:clr>
        </p15:guide>
        <p15:guide id="19" orient="horz" pos="3480" userDrawn="1">
          <p15:clr>
            <a:srgbClr val="A4A3A4"/>
          </p15:clr>
        </p15:guide>
        <p15:guide id="20" pos="2352" userDrawn="1">
          <p15:clr>
            <a:srgbClr val="A4A3A4"/>
          </p15:clr>
        </p15:guide>
        <p15:guide id="21" pos="4128" userDrawn="1">
          <p15:clr>
            <a:srgbClr val="A4A3A4"/>
          </p15:clr>
        </p15:guide>
        <p15:guide id="22" pos="749">
          <p15:clr>
            <a:srgbClr val="A4A3A4"/>
          </p15:clr>
        </p15:guide>
        <p15:guide id="23" pos="408" userDrawn="1">
          <p15:clr>
            <a:srgbClr val="A4A3A4"/>
          </p15:clr>
        </p15:guide>
        <p15:guide id="24" pos="3228">
          <p15:clr>
            <a:srgbClr val="A4A3A4"/>
          </p15:clr>
        </p15:guide>
        <p15:guide id="25" pos="822">
          <p15:clr>
            <a:srgbClr val="A4A3A4"/>
          </p15:clr>
        </p15:guide>
        <p15:guide id="26" orient="horz" pos="2412">
          <p15:clr>
            <a:srgbClr val="A4A3A4"/>
          </p15:clr>
        </p15:guide>
        <p15:guide id="27" orient="horz" pos="2052">
          <p15:clr>
            <a:srgbClr val="A4A3A4"/>
          </p15:clr>
        </p15:guide>
        <p15:guide id="28" orient="horz" pos="5976">
          <p15:clr>
            <a:srgbClr val="A4A3A4"/>
          </p15:clr>
        </p15:guide>
        <p15:guide id="29" pos="180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Iveta Yotova" initials="IY" lastIdx="19" clrIdx="0">
    <p:extLst/>
  </p:cmAuthor>
  <p:cmAuthor id="2" name="ITSC" initials="I" lastIdx="7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09FA4"/>
    <a:srgbClr val="B0B0B4"/>
    <a:srgbClr val="8F8F9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188" autoAdjust="0"/>
    <p:restoredTop sz="94660" autoAdjust="0"/>
  </p:normalViewPr>
  <p:slideViewPr>
    <p:cSldViewPr snapToGrid="0" showGuides="1">
      <p:cViewPr varScale="1">
        <p:scale>
          <a:sx n="78" d="100"/>
          <a:sy n="78" d="100"/>
        </p:scale>
        <p:origin x="2796" y="84"/>
      </p:cViewPr>
      <p:guideLst>
        <p:guide orient="horz" pos="1128"/>
        <p:guide pos="2136"/>
        <p:guide orient="horz" pos="1656"/>
        <p:guide orient="horz" pos="336"/>
        <p:guide orient="horz" pos="3336"/>
        <p:guide pos="4104"/>
        <p:guide pos="240"/>
        <p:guide pos="1320"/>
        <p:guide orient="horz" pos="507"/>
        <p:guide orient="horz" pos="4632"/>
        <p:guide pos="2616"/>
        <p:guide pos="696"/>
        <p:guide orient="horz" pos="4837"/>
        <p:guide orient="horz" pos="1678"/>
        <p:guide orient="horz" pos="410"/>
        <p:guide orient="horz" pos="2976"/>
        <p:guide orient="horz" pos="882"/>
        <p:guide orient="horz" pos="3480"/>
        <p:guide pos="2352"/>
        <p:guide pos="4128"/>
        <p:guide pos="749"/>
        <p:guide pos="408"/>
        <p:guide pos="3228"/>
        <p:guide pos="822"/>
        <p:guide orient="horz" pos="2412"/>
        <p:guide orient="horz" pos="2052"/>
        <p:guide orient="horz" pos="5976"/>
        <p:guide pos="180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E756-CB39-423E-9CCF-070D0F3311E5}" type="datetimeFigureOut">
              <a:rPr lang="en-US" smtClean="0"/>
              <a:t>3/5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B1C5-2342-4ABF-B868-DC21592C9EC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496240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E756-CB39-423E-9CCF-070D0F3311E5}" type="datetimeFigureOut">
              <a:rPr lang="en-US" smtClean="0"/>
              <a:t>3/5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B1C5-2342-4ABF-B868-DC21592C9EC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450365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E756-CB39-423E-9CCF-070D0F3311E5}" type="datetimeFigureOut">
              <a:rPr lang="en-US" smtClean="0"/>
              <a:t>3/5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B1C5-2342-4ABF-B868-DC21592C9EC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088608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E756-CB39-423E-9CCF-070D0F3311E5}" type="datetimeFigureOut">
              <a:rPr lang="en-US" smtClean="0"/>
              <a:t>3/5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B1C5-2342-4ABF-B868-DC21592C9EC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986335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E756-CB39-423E-9CCF-070D0F3311E5}" type="datetimeFigureOut">
              <a:rPr lang="en-US" smtClean="0"/>
              <a:t>3/5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B1C5-2342-4ABF-B868-DC21592C9EC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612265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E756-CB39-423E-9CCF-070D0F3311E5}" type="datetimeFigureOut">
              <a:rPr lang="en-US" smtClean="0"/>
              <a:t>3/5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B1C5-2342-4ABF-B868-DC21592C9EC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379454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E756-CB39-423E-9CCF-070D0F3311E5}" type="datetimeFigureOut">
              <a:rPr lang="en-US" smtClean="0"/>
              <a:t>3/5/2020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B1C5-2342-4ABF-B868-DC21592C9EC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683400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E756-CB39-423E-9CCF-070D0F3311E5}" type="datetimeFigureOut">
              <a:rPr lang="en-US" smtClean="0"/>
              <a:t>3/5/2020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B1C5-2342-4ABF-B868-DC21592C9EC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22868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E756-CB39-423E-9CCF-070D0F3311E5}" type="datetimeFigureOut">
              <a:rPr lang="en-US" smtClean="0"/>
              <a:t>3/5/2020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B1C5-2342-4ABF-B868-DC21592C9EC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579555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E756-CB39-423E-9CCF-070D0F3311E5}" type="datetimeFigureOut">
              <a:rPr lang="en-US" smtClean="0"/>
              <a:t>3/5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B1C5-2342-4ABF-B868-DC21592C9EC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0254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E756-CB39-423E-9CCF-070D0F3311E5}" type="datetimeFigureOut">
              <a:rPr lang="en-US" smtClean="0"/>
              <a:t>3/5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B1C5-2342-4ABF-B868-DC21592C9EC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12901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DEE756-CB39-423E-9CCF-070D0F3311E5}" type="datetimeFigureOut">
              <a:rPr lang="en-US" smtClean="0"/>
              <a:t>3/5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DAB1C5-2342-4ABF-B868-DC21592C9EC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70277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30"/>
          <p:cNvSpPr txBox="1"/>
          <p:nvPr/>
        </p:nvSpPr>
        <p:spPr>
          <a:xfrm>
            <a:off x="0" y="22146"/>
            <a:ext cx="12250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. Figure 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32"/>
          <p:cNvSpPr txBox="1"/>
          <p:nvPr/>
        </p:nvSpPr>
        <p:spPr>
          <a:xfrm>
            <a:off x="96020" y="30430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Gruppieren 11"/>
          <p:cNvGrpSpPr/>
          <p:nvPr/>
        </p:nvGrpSpPr>
        <p:grpSpPr>
          <a:xfrm>
            <a:off x="1151680" y="795337"/>
            <a:ext cx="4412894" cy="1899910"/>
            <a:chOff x="1073506" y="652462"/>
            <a:chExt cx="4412894" cy="1899910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02" t="68453" r="3112" b="1318"/>
            <a:stretch/>
          </p:blipFill>
          <p:spPr>
            <a:xfrm>
              <a:off x="1295400" y="652462"/>
              <a:ext cx="4191000" cy="1638300"/>
            </a:xfrm>
            <a:prstGeom prst="rect">
              <a:avLst/>
            </a:prstGeom>
          </p:spPr>
        </p:pic>
        <p:cxnSp>
          <p:nvCxnSpPr>
            <p:cNvPr id="8" name="Gerade Verbindung mit Pfeil 7"/>
            <p:cNvCxnSpPr/>
            <p:nvPr/>
          </p:nvCxnSpPr>
          <p:spPr>
            <a:xfrm>
              <a:off x="1335116" y="2290761"/>
              <a:ext cx="4135755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" name="Gerade Verbindung mit Pfeil 8"/>
            <p:cNvCxnSpPr/>
            <p:nvPr/>
          </p:nvCxnSpPr>
          <p:spPr>
            <a:xfrm flipV="1">
              <a:off x="1335116" y="682037"/>
              <a:ext cx="0" cy="1608725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TextBox 69"/>
            <p:cNvSpPr txBox="1"/>
            <p:nvPr/>
          </p:nvSpPr>
          <p:spPr>
            <a:xfrm rot="16200000">
              <a:off x="891565" y="1269370"/>
              <a:ext cx="62549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206</a:t>
              </a:r>
              <a:endParaRPr lang="en-US" sz="11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70"/>
            <p:cNvSpPr txBox="1"/>
            <p:nvPr/>
          </p:nvSpPr>
          <p:spPr>
            <a:xfrm>
              <a:off x="3186855" y="2290762"/>
              <a:ext cx="54694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86</a:t>
              </a:r>
              <a:endParaRPr lang="en-US" sz="11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" name="Textfeld 12"/>
          <p:cNvSpPr txBox="1"/>
          <p:nvPr/>
        </p:nvSpPr>
        <p:spPr>
          <a:xfrm>
            <a:off x="1650959" y="650875"/>
            <a:ext cx="4122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TC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2904865" y="650875"/>
            <a:ext cx="12672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  <a:r>
              <a:rPr lang="de-DE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low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/CD68</a:t>
            </a:r>
            <a:r>
              <a:rPr lang="de-DE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4235725" y="650875"/>
            <a:ext cx="13784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  <a:r>
              <a:rPr lang="de-DE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high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/CD68</a:t>
            </a:r>
            <a:r>
              <a:rPr lang="de-DE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74"/>
          <p:cNvSpPr txBox="1"/>
          <p:nvPr/>
        </p:nvSpPr>
        <p:spPr>
          <a:xfrm>
            <a:off x="2845202" y="402595"/>
            <a:ext cx="1972015" cy="26161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M2 (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D163</a:t>
            </a:r>
            <a:r>
              <a:rPr lang="en-US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/CD80</a:t>
            </a:r>
            <a:r>
              <a:rPr lang="en-US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 control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74"/>
          <p:cNvSpPr txBox="1"/>
          <p:nvPr/>
        </p:nvSpPr>
        <p:spPr>
          <a:xfrm>
            <a:off x="2853323" y="2835577"/>
            <a:ext cx="1689886" cy="26161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M2 (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D163</a:t>
            </a:r>
            <a:r>
              <a:rPr lang="en-US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/CD80</a:t>
            </a:r>
            <a:r>
              <a:rPr lang="en-US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 EM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Grafik 18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01" t="14381" r="2746" b="5426"/>
          <a:stretch/>
        </p:blipFill>
        <p:spPr>
          <a:xfrm>
            <a:off x="1468824" y="3252132"/>
            <a:ext cx="4188438" cy="1581150"/>
          </a:xfrm>
          <a:prstGeom prst="rect">
            <a:avLst/>
          </a:prstGeom>
        </p:spPr>
      </p:pic>
      <p:cxnSp>
        <p:nvCxnSpPr>
          <p:cNvPr id="20" name="Gerade Verbindung mit Pfeil 19"/>
          <p:cNvCxnSpPr/>
          <p:nvPr/>
        </p:nvCxnSpPr>
        <p:spPr>
          <a:xfrm>
            <a:off x="1459299" y="4860856"/>
            <a:ext cx="4135755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Gerade Verbindung mit Pfeil 20"/>
          <p:cNvCxnSpPr/>
          <p:nvPr/>
        </p:nvCxnSpPr>
        <p:spPr>
          <a:xfrm flipV="1">
            <a:off x="1459299" y="3252132"/>
            <a:ext cx="0" cy="160872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TextBox 70"/>
          <p:cNvSpPr txBox="1"/>
          <p:nvPr/>
        </p:nvSpPr>
        <p:spPr>
          <a:xfrm>
            <a:off x="3310307" y="4860856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D86</a:t>
            </a:r>
            <a:endParaRPr 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69"/>
          <p:cNvSpPr txBox="1"/>
          <p:nvPr/>
        </p:nvSpPr>
        <p:spPr>
          <a:xfrm rot="16200000">
            <a:off x="1006223" y="3911902"/>
            <a:ext cx="6254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D206</a:t>
            </a:r>
            <a:endParaRPr 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1689449" y="3072140"/>
            <a:ext cx="4122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TC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2987503" y="3072140"/>
            <a:ext cx="12672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  <a:r>
              <a:rPr lang="de-DE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low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/CD68</a:t>
            </a:r>
            <a:r>
              <a:rPr lang="de-DE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4327888" y="3053090"/>
            <a:ext cx="13784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  <a:r>
              <a:rPr lang="de-DE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high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/CD68</a:t>
            </a:r>
            <a:r>
              <a:rPr lang="de-DE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32"/>
          <p:cNvSpPr txBox="1"/>
          <p:nvPr/>
        </p:nvSpPr>
        <p:spPr>
          <a:xfrm>
            <a:off x="86402" y="5247501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8" name="Gruppieren 37"/>
          <p:cNvGrpSpPr/>
          <p:nvPr/>
        </p:nvGrpSpPr>
        <p:grpSpPr>
          <a:xfrm>
            <a:off x="51298" y="5524500"/>
            <a:ext cx="6755403" cy="3228975"/>
            <a:chOff x="51298" y="5524500"/>
            <a:chExt cx="6755403" cy="3228975"/>
          </a:xfrm>
        </p:grpSpPr>
        <p:grpSp>
          <p:nvGrpSpPr>
            <p:cNvPr id="33" name="Gruppieren 32"/>
            <p:cNvGrpSpPr/>
            <p:nvPr/>
          </p:nvGrpSpPr>
          <p:grpSpPr>
            <a:xfrm>
              <a:off x="51298" y="5524500"/>
              <a:ext cx="6755403" cy="3228975"/>
              <a:chOff x="59718" y="5524500"/>
              <a:chExt cx="6755403" cy="3228975"/>
            </a:xfrm>
          </p:grpSpPr>
          <p:pic>
            <p:nvPicPr>
              <p:cNvPr id="4" name="Picture 3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9718" y="5676900"/>
                <a:ext cx="3371850" cy="307657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0" name="TextBox 74"/>
              <p:cNvSpPr txBox="1"/>
              <p:nvPr/>
            </p:nvSpPr>
            <p:spPr>
              <a:xfrm>
                <a:off x="1104900" y="5527045"/>
                <a:ext cx="1972015" cy="261610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2 (</a:t>
                </a:r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D163</a:t>
                </a:r>
                <a:r>
                  <a:rPr lang="en-US" sz="1100" baseline="30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/CD80</a:t>
                </a:r>
                <a:r>
                  <a:rPr lang="en-US" sz="1100" baseline="30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 controls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1" name="Picture 2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327384" y="5552300"/>
                <a:ext cx="3487737" cy="307657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2" name="TextBox 74"/>
              <p:cNvSpPr txBox="1"/>
              <p:nvPr/>
            </p:nvSpPr>
            <p:spPr>
              <a:xfrm>
                <a:off x="4353522" y="5524500"/>
                <a:ext cx="1689886" cy="261610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100" smtClean="0">
                    <a:latin typeface="Arial" panose="020B0604020202020204" pitchFamily="34" charset="0"/>
                    <a:cs typeface="Arial" panose="020B0604020202020204" pitchFamily="34" charset="0"/>
                  </a:rPr>
                  <a:t>M2 (</a:t>
                </a:r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D163</a:t>
                </a:r>
                <a:r>
                  <a:rPr lang="en-US" sz="1100" baseline="30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/CD80</a:t>
                </a:r>
                <a:r>
                  <a:rPr lang="en-US" sz="1100" baseline="30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 EM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6" name="Textfeld 35"/>
            <p:cNvSpPr txBox="1"/>
            <p:nvPr/>
          </p:nvSpPr>
          <p:spPr>
            <a:xfrm>
              <a:off x="811279" y="5920859"/>
              <a:ext cx="5918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&gt;0.05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feld 36"/>
            <p:cNvSpPr txBox="1"/>
            <p:nvPr/>
          </p:nvSpPr>
          <p:spPr>
            <a:xfrm>
              <a:off x="4049187" y="5920859"/>
              <a:ext cx="5918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&gt;0.05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010280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0</Words>
  <Application>Microsoft Office PowerPoint</Application>
  <PresentationFormat>A4 Paper (210x297 mm)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veta Yotova</dc:creator>
  <cp:lastModifiedBy>Quanah</cp:lastModifiedBy>
  <cp:revision>526</cp:revision>
  <cp:lastPrinted>2020-03-05T12:39:43Z</cp:lastPrinted>
  <dcterms:created xsi:type="dcterms:W3CDTF">2019-04-01T12:02:09Z</dcterms:created>
  <dcterms:modified xsi:type="dcterms:W3CDTF">2020-03-05T13:29:42Z</dcterms:modified>
</cp:coreProperties>
</file>